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  <p:sldId id="261" r:id="rId7"/>
  </p:sldIdLst>
  <p:sldSz cx="9144000" cy="6858000" type="screen4x3"/>
  <p:notesSz cx="6858000" cy="9144000"/>
  <p:custDataLst>
    <p:tags r:id="rId8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10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8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D drive data\SHEKHAR BISHT\Phd thesis (SB)New\Shekhar Thesis DATA\Cold tolerance data\Shekhar HPLC Data\Shekhar Sugar analysis\HPLC from Luria broth\NPRs3\NPRp3-.New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76200"/>
            <a:ext cx="8915400" cy="5867400"/>
          </a:xfrm>
          <a:prstGeom prst="rect">
            <a:avLst/>
          </a:prstGeom>
          <a:noFill/>
        </p:spPr>
      </p:pic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76200" y="5874603"/>
            <a:ext cx="9076459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. S1a.  </a:t>
            </a: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HPLC chromatogram of intracellular sugars and </a:t>
            </a:r>
            <a:r>
              <a:rPr lang="en-US" sz="1600" dirty="0" err="1" smtClean="0"/>
              <a:t>polyols</a:t>
            </a: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’ contents of </a:t>
            </a:r>
            <a:r>
              <a:rPr kumimoji="0" lang="en-US" sz="160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seudomonas</a:t>
            </a: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600" i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lurida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NPRs3</a:t>
            </a: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rown at 4</a:t>
            </a: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and </a:t>
            </a: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8</a:t>
            </a: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857250" algn="l"/>
              </a:tabLst>
            </a:pPr>
            <a:r>
              <a:rPr kumimoji="0" lang="en-US" sz="16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	</a:t>
            </a:r>
            <a:endParaRPr kumimoji="0" 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D drive data\SHEKHAR BISHT\Phd thesis (SB)New\Shekhar Thesis DATA\Cold tolerance data\Shekhar HPLC Data\Shekhar Sugar analysis\HPLC from Luria broth\NPRp15\NPRp15-,,New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76200"/>
            <a:ext cx="8915400" cy="5867400"/>
          </a:xfrm>
          <a:prstGeom prst="rect">
            <a:avLst/>
          </a:prstGeom>
          <a:noFill/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53343" y="6027003"/>
            <a:ext cx="9395457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. </a:t>
            </a:r>
            <a:r>
              <a:rPr lang="en-US" sz="16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1</a:t>
            </a: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.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6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HPLC chromatogram of intracellular 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gars and </a:t>
            </a:r>
            <a:r>
              <a:rPr lang="en-US" sz="1600" dirty="0" err="1" smtClean="0"/>
              <a:t>polyols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’ contents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of </a:t>
            </a:r>
            <a:r>
              <a:rPr kumimoji="0" lang="en-US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seudomonas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600" i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lurida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NPRp15 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rown at 4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and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8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	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120088" y="6019800"/>
            <a:ext cx="9270743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. S1c.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6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HPLC chromatogram of intracellular 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gars and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polyols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’ contents of </a:t>
            </a:r>
            <a:r>
              <a:rPr lang="en-US" sz="1600" i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seudomonas 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p. PPERs23 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rown at 4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and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8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	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145" name="Picture 1" descr="E:\D drive data\SHEKHAR BISHT\Phd thesis (SB)New\Shekhar Thesis DATA\Cold tolerance data\Shekhar HPLC Data\Shekhar Sugar analysis\HPLC from Luria broth\PPERs23\PPERs23-,New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76200"/>
            <a:ext cx="8891770" cy="60198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ChangeArrowheads="1"/>
          </p:cNvSpPr>
          <p:nvPr/>
        </p:nvSpPr>
        <p:spPr bwMode="auto">
          <a:xfrm>
            <a:off x="104949" y="6027003"/>
            <a:ext cx="9390969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. S1d.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6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HPLC chromatogram of intracellular 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gars and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polyols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’ contents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of </a:t>
            </a:r>
            <a:r>
              <a:rPr kumimoji="0" lang="en-US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seudomonas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600" i="1" dirty="0" err="1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utida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PGRs4</a:t>
            </a:r>
            <a:r>
              <a:rPr lang="en-US" sz="16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rown at 4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and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8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	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1" name="Picture 1" descr="E:\D drive data\SHEKHAR BISHT\Phd thesis (SB)New\Shekhar Thesis DATA\Cold tolerance data\Shekhar HPLC Data\Shekhar Sugar analysis\HPLC from Luria broth\PGRs4\PGRs4-,,,New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152400"/>
            <a:ext cx="8839200" cy="5867400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ChangeArrowheads="1"/>
          </p:cNvSpPr>
          <p:nvPr/>
        </p:nvSpPr>
        <p:spPr bwMode="auto">
          <a:xfrm>
            <a:off x="223687" y="6103203"/>
            <a:ext cx="9304407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. S1e.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6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HPLC chromatogram of intracellular 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gars and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polyols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’ contents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of </a:t>
            </a:r>
            <a:r>
              <a:rPr lang="en-US" sz="1600" i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seudomonas 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p. PGERs17</a:t>
            </a:r>
            <a:r>
              <a:rPr lang="en-US" sz="16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rown at 4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and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8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	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97" name="Picture 1" descr="E:\D drive data\SHEKHAR BISHT\Phd thesis (SB)New\Shekhar Thesis DATA\Cold tolerance data\Shekhar HPLC Data\Shekhar Sugar analysis\HPLC from Luria broth\PGERs17\PGERs17-,,-New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76200"/>
            <a:ext cx="9067800" cy="60198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228600" y="6135469"/>
            <a:ext cx="8610600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. </a:t>
            </a:r>
            <a:r>
              <a:rPr kumimoji="0" lang="en-US" sz="1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1f</a:t>
            </a:r>
            <a:r>
              <a:rPr lang="en-US" sz="160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kumimoji="0" lang="en-US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HPLC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hromatogram of intracellular 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gars and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polyols</a:t>
            </a:r>
            <a:r>
              <a:rPr lang="en-US" sz="16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’ contents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of </a:t>
            </a:r>
            <a:r>
              <a:rPr kumimoji="0" lang="en-US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seudomonas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   </a:t>
            </a:r>
            <a:r>
              <a:rPr lang="en-US" sz="1600" i="1" dirty="0" err="1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ﬂuorescens</a:t>
            </a:r>
            <a:r>
              <a:rPr lang="en-US" sz="16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PPRs4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rown at 4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and 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8</a:t>
            </a: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°C 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857250" algn="l"/>
              </a:tabLst>
            </a:pPr>
            <a:r>
              <a:rPr kumimoji="0" lang="en-US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	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3" name="Picture 1" descr="E:\D drive data\SHEKHAR BISHT\Phd thesis (SB)New\Shekhar Thesis DATA\Cold tolerance data\Shekhar HPLC Data\Shekhar Sugar analysis\HPLC from Luria broth\PPRs4\PPRs4-,New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76200"/>
            <a:ext cx="8932945" cy="61722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PROJECT_OPEN" val="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34</Words>
  <Application>Microsoft Office PowerPoint</Application>
  <PresentationFormat>On-screen Show (4:3)</PresentationFormat>
  <Paragraphs>17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ekhar</dc:creator>
  <cp:lastModifiedBy>Selvakumar</cp:lastModifiedBy>
  <cp:revision>11</cp:revision>
  <dcterms:created xsi:type="dcterms:W3CDTF">2006-08-16T00:00:00Z</dcterms:created>
  <dcterms:modified xsi:type="dcterms:W3CDTF">2013-08-18T18:07:41Z</dcterms:modified>
</cp:coreProperties>
</file>